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690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72" y="3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7B560-8FBF-46D6-BBC5-CC12EE68624F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480AF-3525-492C-95C6-53FCC2222E7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81701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7B560-8FBF-46D6-BBC5-CC12EE68624F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480AF-3525-492C-95C6-53FCC2222E7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4941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7B560-8FBF-46D6-BBC5-CC12EE68624F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480AF-3525-492C-95C6-53FCC2222E7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1161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7B560-8FBF-46D6-BBC5-CC12EE68624F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480AF-3525-492C-95C6-53FCC2222E7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1281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7B560-8FBF-46D6-BBC5-CC12EE68624F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480AF-3525-492C-95C6-53FCC2222E7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6147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7B560-8FBF-46D6-BBC5-CC12EE68624F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480AF-3525-492C-95C6-53FCC2222E7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8381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7B560-8FBF-46D6-BBC5-CC12EE68624F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480AF-3525-492C-95C6-53FCC2222E7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3571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7B560-8FBF-46D6-BBC5-CC12EE68624F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480AF-3525-492C-95C6-53FCC2222E7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3520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7B560-8FBF-46D6-BBC5-CC12EE68624F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480AF-3525-492C-95C6-53FCC2222E7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6913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7B560-8FBF-46D6-BBC5-CC12EE68624F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480AF-3525-492C-95C6-53FCC2222E7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7453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7B560-8FBF-46D6-BBC5-CC12EE68624F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480AF-3525-492C-95C6-53FCC2222E7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0693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27B560-8FBF-46D6-BBC5-CC12EE68624F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F480AF-3525-492C-95C6-53FCC2222E7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0686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/>
          <p:cNvSpPr txBox="1"/>
          <p:nvPr/>
        </p:nvSpPr>
        <p:spPr>
          <a:xfrm>
            <a:off x="800656" y="2036728"/>
            <a:ext cx="16979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mb_jn3_01426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3053608" y="2036728"/>
            <a:ext cx="16979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mb_jn3_01427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5306560" y="2036728"/>
            <a:ext cx="16979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mb_jn3_01428</a:t>
            </a:r>
          </a:p>
        </p:txBody>
      </p:sp>
      <p:sp>
        <p:nvSpPr>
          <p:cNvPr id="12" name="ZoneTexte 11"/>
          <p:cNvSpPr txBox="1"/>
          <p:nvPr/>
        </p:nvSpPr>
        <p:spPr>
          <a:xfrm>
            <a:off x="7262356" y="2010249"/>
            <a:ext cx="16979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mb_jn3_03263</a:t>
            </a:r>
          </a:p>
        </p:txBody>
      </p:sp>
      <p:sp>
        <p:nvSpPr>
          <p:cNvPr id="13" name="ZoneTexte 12"/>
          <p:cNvSpPr txBox="1"/>
          <p:nvPr/>
        </p:nvSpPr>
        <p:spPr>
          <a:xfrm>
            <a:off x="9522055" y="2010249"/>
            <a:ext cx="16979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mb_jn3_03815</a:t>
            </a:r>
          </a:p>
        </p:txBody>
      </p:sp>
      <p:sp>
        <p:nvSpPr>
          <p:cNvPr id="15" name="ZoneTexte 14"/>
          <p:cNvSpPr txBox="1"/>
          <p:nvPr/>
        </p:nvSpPr>
        <p:spPr>
          <a:xfrm>
            <a:off x="3161554" y="4148603"/>
            <a:ext cx="16979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mb_jn3_08418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5402842" y="4148603"/>
            <a:ext cx="16979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mb_jn3_08419</a:t>
            </a:r>
          </a:p>
        </p:txBody>
      </p:sp>
      <p:sp>
        <p:nvSpPr>
          <p:cNvPr id="17" name="ZoneTexte 16"/>
          <p:cNvSpPr txBox="1"/>
          <p:nvPr/>
        </p:nvSpPr>
        <p:spPr>
          <a:xfrm>
            <a:off x="7442483" y="4106833"/>
            <a:ext cx="16979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mb_jn3_08421</a:t>
            </a:r>
          </a:p>
        </p:txBody>
      </p:sp>
      <p:sp>
        <p:nvSpPr>
          <p:cNvPr id="31" name="Rectangle 30"/>
          <p:cNvSpPr/>
          <p:nvPr/>
        </p:nvSpPr>
        <p:spPr>
          <a:xfrm>
            <a:off x="943683" y="4680188"/>
            <a:ext cx="9092851" cy="9597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300"/>
              </a:spcAf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 S3. 3D models of the LARS effectors identified in </a:t>
            </a:r>
            <a:r>
              <a:rPr lang="en-US" sz="1200" b="1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200" b="1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culans</a:t>
            </a:r>
            <a:endParaRPr lang="en-US" sz="1200" b="1" i="1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300"/>
              </a:spcAft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3D structures of the different LARS effectors found by the HMM search were modeled using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AlphaFold2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27]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tein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presented as sticks and colored in red. No reliable models could be obtained for Lmb_jn3_08343 or Lmb_jn3_12986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300"/>
              </a:spcAft>
            </a:pPr>
            <a:endParaRPr lang="fr-FR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A233670C-B4A9-574C-86CF-683EB92AF2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37743" y="286022"/>
            <a:ext cx="2474375" cy="1520204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74C0E7F5-FBD0-F44F-8F71-7F85D2A361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53608" y="2553900"/>
            <a:ext cx="1946385" cy="1475155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F2B08B0F-A06E-4048-ADBE-9E0D67B75E7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67866" y="2457082"/>
            <a:ext cx="1790076" cy="1475155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0017135A-78E9-D54E-BCF5-47F7853FA8D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62356" y="2500081"/>
            <a:ext cx="1861076" cy="1432257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0710F3B7-0BBC-9141-878B-6D30F9489FC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7411" y="286022"/>
            <a:ext cx="1895048" cy="1520204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BB73CCED-F88B-D74E-964F-697FEA84E22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12790" y="255474"/>
            <a:ext cx="1946665" cy="1475155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3048A5C7-D557-8A45-B1A9-F5DC48A9644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64129" y="218302"/>
            <a:ext cx="2063742" cy="1672475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F700F1A2-6AD6-7A44-81ED-1760702F174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243621" y="270513"/>
            <a:ext cx="2035589" cy="1568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041868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62</Words>
  <Application>Microsoft Office PowerPoint</Application>
  <PresentationFormat>Grand écran</PresentationFormat>
  <Paragraphs>1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sabelle Fudal</dc:creator>
  <cp:lastModifiedBy>Isabelle Fudal</cp:lastModifiedBy>
  <cp:revision>13</cp:revision>
  <dcterms:created xsi:type="dcterms:W3CDTF">2021-08-18T17:24:01Z</dcterms:created>
  <dcterms:modified xsi:type="dcterms:W3CDTF">2022-06-21T15:00:45Z</dcterms:modified>
</cp:coreProperties>
</file>